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19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451"/>
    <p:restoredTop sz="94567" autoAdjust="0"/>
  </p:normalViewPr>
  <p:slideViewPr>
    <p:cSldViewPr snapToGrid="0" snapToObjects="1">
      <p:cViewPr>
        <p:scale>
          <a:sx n="150" d="100"/>
          <a:sy n="150" d="100"/>
        </p:scale>
        <p:origin x="760" y="160"/>
      </p:cViewPr>
      <p:guideLst>
        <p:guide orient="horz" pos="2880"/>
        <p:guide pos="192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nsen:Documents:&#30740;&#31350;:&#20491;&#20154;&#12501;&#12457;&#12523;&#12480;%20(Personal%20Folder):&#31070;&#23665;:&#35542;&#25991;:ZIKA-EAE:20200929%20%20zika,%20EAE%20%20control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ganorikamiyama:Desktop:ZIKV%20EAE%20&#35542;&#25991;:ZIKA%20EAE&#12487;&#12540;&#12479;:20200929%20%20zika,%20EAE%20%20contro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2956383074989"/>
          <c:y val="0.0688787983465751"/>
          <c:w val="0.871884370282028"/>
          <c:h val="0.729499066318893"/>
        </c:manualLayout>
      </c:layout>
      <c:lineChart>
        <c:grouping val="standard"/>
        <c:varyColors val="0"/>
        <c:ser>
          <c:idx val="1"/>
          <c:order val="0"/>
          <c:tx>
            <c:strRef>
              <c:f>Sheet1!$A$53</c:f>
              <c:strCache>
                <c:ptCount val="1"/>
                <c:pt idx="0">
                  <c:v>ZIKV</c:v>
                </c:pt>
              </c:strCache>
            </c:strRef>
          </c:tx>
          <c:spPr>
            <a:ln w="15875">
              <a:solidFill>
                <a:srgbClr val="FF0000"/>
              </a:solidFill>
            </a:ln>
            <a:effectLst/>
          </c:spPr>
          <c:marker>
            <c:symbol val="circle"/>
            <c:size val="4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</c:marker>
          <c:cat>
            <c:strRef>
              <c:f>Sheet1!$B$26:$W$26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53:$W$53</c:f>
              <c:numCache>
                <c:formatCode>General</c:formatCode>
                <c:ptCount val="22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2257-BF4F-A517-FEECBB90BB9A}"/>
            </c:ext>
          </c:extLst>
        </c:ser>
        <c:ser>
          <c:idx val="0"/>
          <c:order val="1"/>
          <c:tx>
            <c:strRef>
              <c:f>Sheet1!$A$52</c:f>
              <c:strCache>
                <c:ptCount val="1"/>
                <c:pt idx="0">
                  <c:v>(-)</c:v>
                </c:pt>
              </c:strCache>
            </c:strRef>
          </c:tx>
          <c:spPr>
            <a:ln w="15875">
              <a:solidFill>
                <a:schemeClr val="tx1"/>
              </a:solidFill>
            </a:ln>
            <a:effectLst/>
          </c:spPr>
          <c:marker>
            <c:symbol val="triang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cat>
            <c:strRef>
              <c:f>Sheet1!$B$26:$W$26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52:$W$52</c:f>
              <c:numCache>
                <c:formatCode>General</c:formatCode>
                <c:ptCount val="22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2257-BF4F-A517-FEECBB90BB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03857936"/>
        <c:axId val="-2004767696"/>
      </c:lineChart>
      <c:catAx>
        <c:axId val="-20038579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ja-JP"/>
          </a:p>
        </c:txPr>
        <c:crossAx val="-2004767696"/>
        <c:crosses val="autoZero"/>
        <c:auto val="1"/>
        <c:lblAlgn val="ctr"/>
        <c:lblOffset val="100"/>
        <c:noMultiLvlLbl val="0"/>
      </c:catAx>
      <c:valAx>
        <c:axId val="-2004767696"/>
        <c:scaling>
          <c:orientation val="minMax"/>
          <c:max val="5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ja-JP"/>
          </a:p>
        </c:txPr>
        <c:crossAx val="-200385793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74468503937008"/>
          <c:y val="0.0601851851851852"/>
          <c:w val="0.882896762904637"/>
          <c:h val="0.756798993875765"/>
        </c:manualLayout>
      </c:layout>
      <c:lineChart>
        <c:grouping val="standard"/>
        <c:varyColors val="0"/>
        <c:ser>
          <c:idx val="0"/>
          <c:order val="0"/>
          <c:tx>
            <c:strRef>
              <c:f>Sheet1!$A$27</c:f>
              <c:strCache>
                <c:ptCount val="1"/>
                <c:pt idx="0">
                  <c:v>(-)</c:v>
                </c:pt>
              </c:strCache>
            </c:strRef>
          </c:tx>
          <c:spPr>
            <a:ln w="15875">
              <a:solidFill>
                <a:schemeClr val="tx1"/>
              </a:solidFill>
            </a:ln>
            <a:effectLst/>
          </c:spPr>
          <c:marker>
            <c:symbol val="triang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Ref>
                <c:f>Sheet1!$B$29:$W$29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1.53467387785374</c:v>
                  </c:pt>
                  <c:pt idx="2">
                    <c:v>1.089370396285734</c:v>
                  </c:pt>
                  <c:pt idx="3">
                    <c:v>2.019473983831153</c:v>
                  </c:pt>
                  <c:pt idx="4">
                    <c:v>1.265261732140738</c:v>
                  </c:pt>
                  <c:pt idx="5">
                    <c:v>1.36004948432888</c:v>
                  </c:pt>
                  <c:pt idx="6">
                    <c:v>1.279195513938224</c:v>
                  </c:pt>
                  <c:pt idx="7">
                    <c:v>1.365118994451602</c:v>
                  </c:pt>
                  <c:pt idx="8">
                    <c:v>2.050063020850263</c:v>
                  </c:pt>
                  <c:pt idx="9">
                    <c:v>1.854946884770165</c:v>
                  </c:pt>
                  <c:pt idx="10">
                    <c:v>1.79893438042562</c:v>
                  </c:pt>
                  <c:pt idx="11">
                    <c:v>2.317140774689545</c:v>
                  </c:pt>
                  <c:pt idx="12">
                    <c:v>2.239781822464603</c:v>
                  </c:pt>
                  <c:pt idx="13">
                    <c:v>1.846923111596883</c:v>
                  </c:pt>
                  <c:pt idx="14">
                    <c:v>2.693826414633757</c:v>
                  </c:pt>
                  <c:pt idx="15">
                    <c:v>2.317965258031451</c:v>
                  </c:pt>
                  <c:pt idx="16">
                    <c:v>2.214632385558636</c:v>
                  </c:pt>
                  <c:pt idx="17">
                    <c:v>1.018218631503425</c:v>
                  </c:pt>
                  <c:pt idx="18">
                    <c:v>2.541694310153253</c:v>
                  </c:pt>
                  <c:pt idx="19">
                    <c:v>2.38760464584495</c:v>
                  </c:pt>
                  <c:pt idx="20">
                    <c:v>2.271313708804246</c:v>
                  </c:pt>
                  <c:pt idx="21">
                    <c:v>1.298544967433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ln w="0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cat>
            <c:strRef>
              <c:f>Sheet1!$B$26:$W$26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27:$W$27</c:f>
              <c:numCache>
                <c:formatCode>General</c:formatCode>
                <c:ptCount val="22"/>
                <c:pt idx="0">
                  <c:v>100.0</c:v>
                </c:pt>
                <c:pt idx="1">
                  <c:v>100.5335082310189</c:v>
                </c:pt>
                <c:pt idx="2">
                  <c:v>101.6885727463503</c:v>
                </c:pt>
                <c:pt idx="3">
                  <c:v>102.6629783647449</c:v>
                </c:pt>
                <c:pt idx="4">
                  <c:v>102.4192548041197</c:v>
                </c:pt>
                <c:pt idx="5">
                  <c:v>101.5629561377901</c:v>
                </c:pt>
                <c:pt idx="6">
                  <c:v>101.5735033894777</c:v>
                </c:pt>
                <c:pt idx="7">
                  <c:v>101.6588670427967</c:v>
                </c:pt>
                <c:pt idx="8">
                  <c:v>102.6452562068638</c:v>
                </c:pt>
                <c:pt idx="9">
                  <c:v>101.0034872689533</c:v>
                </c:pt>
                <c:pt idx="10">
                  <c:v>100.982149824431</c:v>
                </c:pt>
                <c:pt idx="11">
                  <c:v>101.3431217345852</c:v>
                </c:pt>
                <c:pt idx="12">
                  <c:v>101.6549838063607</c:v>
                </c:pt>
                <c:pt idx="13">
                  <c:v>101.9452654924666</c:v>
                </c:pt>
                <c:pt idx="14">
                  <c:v>104.0659973887316</c:v>
                </c:pt>
                <c:pt idx="15">
                  <c:v>104.4655291437651</c:v>
                </c:pt>
                <c:pt idx="16">
                  <c:v>104.2988009774277</c:v>
                </c:pt>
                <c:pt idx="17">
                  <c:v>103.5897104387457</c:v>
                </c:pt>
                <c:pt idx="18">
                  <c:v>103.519138860374</c:v>
                </c:pt>
                <c:pt idx="19">
                  <c:v>104.0788506703581</c:v>
                </c:pt>
                <c:pt idx="20">
                  <c:v>104.9290871075952</c:v>
                </c:pt>
                <c:pt idx="21">
                  <c:v>104.877428298130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CA5-7749-8BE0-23F3AFAD9654}"/>
            </c:ext>
          </c:extLst>
        </c:ser>
        <c:ser>
          <c:idx val="1"/>
          <c:order val="1"/>
          <c:tx>
            <c:strRef>
              <c:f>Sheet1!$A$28</c:f>
              <c:strCache>
                <c:ptCount val="1"/>
                <c:pt idx="0">
                  <c:v>ZIKV</c:v>
                </c:pt>
              </c:strCache>
            </c:strRef>
          </c:tx>
          <c:spPr>
            <a:ln w="15875">
              <a:solidFill>
                <a:srgbClr val="FF0000"/>
              </a:solidFill>
            </a:ln>
            <a:effectLst/>
          </c:spPr>
          <c:marker>
            <c:symbol val="circle"/>
            <c:size val="4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1!$B$30:$W$30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1.368417069461797</c:v>
                  </c:pt>
                  <c:pt idx="2">
                    <c:v>1.033255857089157</c:v>
                  </c:pt>
                  <c:pt idx="3">
                    <c:v>0.670624328836132</c:v>
                  </c:pt>
                  <c:pt idx="4">
                    <c:v>0.857779380939685</c:v>
                  </c:pt>
                  <c:pt idx="5">
                    <c:v>1.236097596557477</c:v>
                  </c:pt>
                  <c:pt idx="6">
                    <c:v>1.211485375025784</c:v>
                  </c:pt>
                  <c:pt idx="7">
                    <c:v>1.3211158126881</c:v>
                  </c:pt>
                  <c:pt idx="8">
                    <c:v>1.863467977551108</c:v>
                  </c:pt>
                  <c:pt idx="9">
                    <c:v>1.095628776259945</c:v>
                  </c:pt>
                  <c:pt idx="10">
                    <c:v>1.787850641477591</c:v>
                  </c:pt>
                  <c:pt idx="11">
                    <c:v>1.269990938816564</c:v>
                  </c:pt>
                  <c:pt idx="12">
                    <c:v>1.240601015337836</c:v>
                  </c:pt>
                  <c:pt idx="13">
                    <c:v>1.343756553995614</c:v>
                  </c:pt>
                  <c:pt idx="14">
                    <c:v>0.778270663581705</c:v>
                  </c:pt>
                  <c:pt idx="15">
                    <c:v>0.855505421486295</c:v>
                  </c:pt>
                  <c:pt idx="16">
                    <c:v>2.715191640057048</c:v>
                  </c:pt>
                  <c:pt idx="17">
                    <c:v>2.71413478874644</c:v>
                  </c:pt>
                  <c:pt idx="18">
                    <c:v>2.910173959124182</c:v>
                  </c:pt>
                  <c:pt idx="19">
                    <c:v>3.024568862648362</c:v>
                  </c:pt>
                  <c:pt idx="20">
                    <c:v>3.14313062941656</c:v>
                  </c:pt>
                  <c:pt idx="21">
                    <c:v>3.2792620659309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ln w="0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cat>
            <c:strRef>
              <c:f>Sheet1!$B$26:$W$26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28:$W$28</c:f>
              <c:numCache>
                <c:formatCode>General</c:formatCode>
                <c:ptCount val="22"/>
                <c:pt idx="0">
                  <c:v>100.0</c:v>
                </c:pt>
                <c:pt idx="1">
                  <c:v>102.8522575303087</c:v>
                </c:pt>
                <c:pt idx="2">
                  <c:v>102.3660472128484</c:v>
                </c:pt>
                <c:pt idx="3">
                  <c:v>103.4656878827647</c:v>
                </c:pt>
                <c:pt idx="4">
                  <c:v>103.5697428446444</c:v>
                </c:pt>
                <c:pt idx="5">
                  <c:v>103.2882577177853</c:v>
                </c:pt>
                <c:pt idx="6">
                  <c:v>103.2178704224472</c:v>
                </c:pt>
                <c:pt idx="7">
                  <c:v>103.6791924446944</c:v>
                </c:pt>
                <c:pt idx="8">
                  <c:v>105.1266005811773</c:v>
                </c:pt>
                <c:pt idx="9">
                  <c:v>105.0804079177603</c:v>
                </c:pt>
                <c:pt idx="10">
                  <c:v>102.9450529621297</c:v>
                </c:pt>
                <c:pt idx="11">
                  <c:v>101.8487978065242</c:v>
                </c:pt>
                <c:pt idx="12">
                  <c:v>103.7709583177103</c:v>
                </c:pt>
                <c:pt idx="13">
                  <c:v>104.1521341082365</c:v>
                </c:pt>
                <c:pt idx="14">
                  <c:v>105.9334958130234</c:v>
                </c:pt>
                <c:pt idx="15">
                  <c:v>106.6718144606924</c:v>
                </c:pt>
                <c:pt idx="16">
                  <c:v>106.6928837020372</c:v>
                </c:pt>
                <c:pt idx="17">
                  <c:v>103.4371289526309</c:v>
                </c:pt>
                <c:pt idx="18">
                  <c:v>103.6842269716285</c:v>
                </c:pt>
                <c:pt idx="19">
                  <c:v>104.5301102987127</c:v>
                </c:pt>
                <c:pt idx="20">
                  <c:v>106.2242329083865</c:v>
                </c:pt>
                <c:pt idx="21">
                  <c:v>105.449480533683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CA5-7749-8BE0-23F3AFAD96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74110368"/>
        <c:axId val="-2004168848"/>
      </c:lineChart>
      <c:catAx>
        <c:axId val="-20741103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ja-JP"/>
          </a:p>
        </c:txPr>
        <c:crossAx val="-2004168848"/>
        <c:crosses val="autoZero"/>
        <c:auto val="1"/>
        <c:lblAlgn val="ctr"/>
        <c:lblOffset val="100"/>
        <c:noMultiLvlLbl val="0"/>
      </c:catAx>
      <c:valAx>
        <c:axId val="-2004168848"/>
        <c:scaling>
          <c:orientation val="minMax"/>
          <c:max val="115.0"/>
          <c:min val="8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ja-JP"/>
          </a:p>
        </c:txPr>
        <c:crossAx val="-207411036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B4E21-F6CD-9F42-BC12-6716A2311E9A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999E1D-F594-7D47-B0D0-FBEEAB6878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878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732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425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896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162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975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4498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597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900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2179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040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887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608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7" name="グラフ 7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518895"/>
              </p:ext>
            </p:extLst>
          </p:nvPr>
        </p:nvGraphicFramePr>
        <p:xfrm>
          <a:off x="325708" y="2743819"/>
          <a:ext cx="2885679" cy="22856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テキスト ボックス 45"/>
          <p:cNvSpPr txBox="1">
            <a:spLocks noChangeArrowheads="1"/>
          </p:cNvSpPr>
          <p:nvPr/>
        </p:nvSpPr>
        <p:spPr bwMode="auto">
          <a:xfrm>
            <a:off x="1326163" y="32098"/>
            <a:ext cx="567170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800" dirty="0">
                <a:latin typeface="Helvetica"/>
                <a:cs typeface="Helvetica"/>
              </a:rPr>
              <a:t> </a:t>
            </a:r>
            <a:r>
              <a:rPr lang="en-US" altLang="ja-JP" dirty="0">
                <a:latin typeface="Helvetica"/>
                <a:cs typeface="Helvetica"/>
              </a:rPr>
              <a:t>Supplementary Fig.S1_Kamiyama et al.</a:t>
            </a:r>
            <a:endParaRPr lang="ja-JP" altLang="en-US" dirty="0">
              <a:latin typeface="Helvetica"/>
              <a:cs typeface="Helvetica"/>
            </a:endParaRPr>
          </a:p>
        </p:txBody>
      </p:sp>
      <p:sp>
        <p:nvSpPr>
          <p:cNvPr id="27" name="正方形/長方形 26"/>
          <p:cNvSpPr/>
          <p:nvPr/>
        </p:nvSpPr>
        <p:spPr>
          <a:xfrm rot="5400000">
            <a:off x="-508610" y="3618884"/>
            <a:ext cx="1836204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389449" y="4443961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EF05A6EE-448A-1840-A05D-D94077708515}"/>
              </a:ext>
            </a:extLst>
          </p:cNvPr>
          <p:cNvSpPr txBox="1"/>
          <p:nvPr/>
        </p:nvSpPr>
        <p:spPr>
          <a:xfrm>
            <a:off x="375242" y="413297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AC0C3899-0921-4F4C-93E7-1B96239CE567}"/>
              </a:ext>
            </a:extLst>
          </p:cNvPr>
          <p:cNvSpPr txBox="1"/>
          <p:nvPr/>
        </p:nvSpPr>
        <p:spPr>
          <a:xfrm>
            <a:off x="375242" y="378843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0E4B548D-540A-954F-AAC0-F6D6CA09E4FA}"/>
              </a:ext>
            </a:extLst>
          </p:cNvPr>
          <p:cNvSpPr txBox="1"/>
          <p:nvPr/>
        </p:nvSpPr>
        <p:spPr>
          <a:xfrm>
            <a:off x="375242" y="345194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F4C64E0E-D4C1-7F4F-9D02-BDC788DDE822}"/>
              </a:ext>
            </a:extLst>
          </p:cNvPr>
          <p:cNvSpPr txBox="1"/>
          <p:nvPr/>
        </p:nvSpPr>
        <p:spPr>
          <a:xfrm>
            <a:off x="375242" y="279732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 rot="16200000">
            <a:off x="-328408" y="3653707"/>
            <a:ext cx="12024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charset="0"/>
                <a:ea typeface="Helvetica" charset="0"/>
                <a:cs typeface="Helvetica" charset="0"/>
              </a:rPr>
              <a:t>Clinical Score</a:t>
            </a:r>
            <a:endParaRPr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0E4B548D-540A-954F-AAC0-F6D6CA09E4FA}"/>
              </a:ext>
            </a:extLst>
          </p:cNvPr>
          <p:cNvSpPr txBox="1"/>
          <p:nvPr/>
        </p:nvSpPr>
        <p:spPr>
          <a:xfrm>
            <a:off x="369882" y="312980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8" name="正方形/長方形 27"/>
          <p:cNvSpPr/>
          <p:nvPr/>
        </p:nvSpPr>
        <p:spPr>
          <a:xfrm rot="5400000">
            <a:off x="343039" y="3604460"/>
            <a:ext cx="980932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1028495" y="2948139"/>
            <a:ext cx="543739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1029706" y="3152887"/>
            <a:ext cx="491381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ja-JP" altLang="ja-JP" sz="1050" b="1" dirty="0">
                <a:latin typeface="Helvetica"/>
                <a:ea typeface="Helvetica" charset="0"/>
                <a:cs typeface="Helvetica"/>
              </a:rPr>
              <a:t>Z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IKV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</a:p>
        </p:txBody>
      </p:sp>
      <p:graphicFrame>
        <p:nvGraphicFramePr>
          <p:cNvPr id="33" name="グラフ 32">
            <a:extLst>
              <a:ext uri="{FF2B5EF4-FFF2-40B4-BE49-F238E27FC236}">
                <a16:creationId xmlns:a16="http://schemas.microsoft.com/office/drawing/2014/main" xmlns="" id="{00000000-0008-0000-0000-000006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0806586"/>
              </p:ext>
            </p:extLst>
          </p:nvPr>
        </p:nvGraphicFramePr>
        <p:xfrm>
          <a:off x="3616604" y="2771436"/>
          <a:ext cx="2816244" cy="22228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4381128" y="3949622"/>
            <a:ext cx="543739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4389473" y="4182910"/>
            <a:ext cx="491381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ja-JP" altLang="ja-JP" sz="1050" b="1" dirty="0">
                <a:latin typeface="Helvetica"/>
                <a:ea typeface="Helvetica" charset="0"/>
                <a:cs typeface="Helvetica"/>
              </a:rPr>
              <a:t>Z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IKV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</a:p>
        </p:txBody>
      </p:sp>
      <p:sp>
        <p:nvSpPr>
          <p:cNvPr id="63" name="正方形/長方形 62"/>
          <p:cNvSpPr/>
          <p:nvPr/>
        </p:nvSpPr>
        <p:spPr>
          <a:xfrm>
            <a:off x="3850672" y="4618738"/>
            <a:ext cx="2589104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xmlns="" id="{79394661-8AAD-894B-B321-DF2F09BB1A34}"/>
              </a:ext>
            </a:extLst>
          </p:cNvPr>
          <p:cNvSpPr txBox="1"/>
          <p:nvPr/>
        </p:nvSpPr>
        <p:spPr>
          <a:xfrm>
            <a:off x="4030396" y="455817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xmlns="" id="{64CEF990-A5BD-1841-BC92-8E9FF5558D96}"/>
              </a:ext>
            </a:extLst>
          </p:cNvPr>
          <p:cNvSpPr txBox="1"/>
          <p:nvPr/>
        </p:nvSpPr>
        <p:spPr>
          <a:xfrm>
            <a:off x="4210121" y="455817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xmlns="" id="{B6F9BB82-7EF2-C24B-863C-A6CC60B52B68}"/>
              </a:ext>
            </a:extLst>
          </p:cNvPr>
          <p:cNvSpPr txBox="1"/>
          <p:nvPr/>
        </p:nvSpPr>
        <p:spPr>
          <a:xfrm>
            <a:off x="4389846" y="455817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xmlns="" id="{708A8313-4EBE-A84D-8CE5-144CF9CD6118}"/>
              </a:ext>
            </a:extLst>
          </p:cNvPr>
          <p:cNvSpPr txBox="1"/>
          <p:nvPr/>
        </p:nvSpPr>
        <p:spPr>
          <a:xfrm>
            <a:off x="4569571" y="455817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4749296" y="4558175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xmlns="" id="{EE14A61E-8929-9048-B5CD-28FB87B52101}"/>
              </a:ext>
            </a:extLst>
          </p:cNvPr>
          <p:cNvSpPr txBox="1"/>
          <p:nvPr/>
        </p:nvSpPr>
        <p:spPr>
          <a:xfrm>
            <a:off x="5014607" y="4558175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xmlns="" id="{AC43DEE9-DE8D-1F42-9452-B6EC573F5AEF}"/>
              </a:ext>
            </a:extLst>
          </p:cNvPr>
          <p:cNvSpPr txBox="1"/>
          <p:nvPr/>
        </p:nvSpPr>
        <p:spPr>
          <a:xfrm>
            <a:off x="5279918" y="4558175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5545229" y="4558175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xmlns="" id="{DA6CE7E4-2C9E-4C44-9865-4688AC918023}"/>
              </a:ext>
            </a:extLst>
          </p:cNvPr>
          <p:cNvSpPr txBox="1"/>
          <p:nvPr/>
        </p:nvSpPr>
        <p:spPr>
          <a:xfrm>
            <a:off x="5810540" y="4558175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xmlns="" id="{C0F527A3-9827-C44F-AD18-EDB55DE1211A}"/>
              </a:ext>
            </a:extLst>
          </p:cNvPr>
          <p:cNvSpPr txBox="1"/>
          <p:nvPr/>
        </p:nvSpPr>
        <p:spPr>
          <a:xfrm>
            <a:off x="6075853" y="4558175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xmlns="" id="{79394661-8AAD-894B-B321-DF2F09BB1A34}"/>
              </a:ext>
            </a:extLst>
          </p:cNvPr>
          <p:cNvSpPr txBox="1"/>
          <p:nvPr/>
        </p:nvSpPr>
        <p:spPr>
          <a:xfrm>
            <a:off x="3850671" y="455563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8" name="正方形/長方形 77"/>
          <p:cNvSpPr/>
          <p:nvPr/>
        </p:nvSpPr>
        <p:spPr>
          <a:xfrm rot="5400000">
            <a:off x="2739005" y="3564342"/>
            <a:ext cx="1953759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3626333" y="4429242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8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xmlns="" id="{EF05A6EE-448A-1840-A05D-D94077708515}"/>
              </a:ext>
            </a:extLst>
          </p:cNvPr>
          <p:cNvSpPr txBox="1"/>
          <p:nvPr/>
        </p:nvSpPr>
        <p:spPr>
          <a:xfrm>
            <a:off x="3616604" y="3941435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9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 rot="16200000">
            <a:off x="2659089" y="3668562"/>
            <a:ext cx="1638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charset="0"/>
                <a:ea typeface="Helvetica" charset="0"/>
                <a:cs typeface="Helvetica" charset="0"/>
              </a:rPr>
              <a:t>% of original weight</a:t>
            </a:r>
            <a:endParaRPr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xmlns="" id="{EF05A6EE-448A-1840-A05D-D94077708515}"/>
              </a:ext>
            </a:extLst>
          </p:cNvPr>
          <p:cNvSpPr txBox="1"/>
          <p:nvPr/>
        </p:nvSpPr>
        <p:spPr>
          <a:xfrm>
            <a:off x="3538209" y="3475760"/>
            <a:ext cx="4414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xmlns="" id="{EF05A6EE-448A-1840-A05D-D94077708515}"/>
              </a:ext>
            </a:extLst>
          </p:cNvPr>
          <p:cNvSpPr txBox="1"/>
          <p:nvPr/>
        </p:nvSpPr>
        <p:spPr>
          <a:xfrm>
            <a:off x="3549969" y="2959076"/>
            <a:ext cx="4330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0" name="テキスト ボックス 44"/>
          <p:cNvSpPr txBox="1">
            <a:spLocks noChangeArrowheads="1"/>
          </p:cNvSpPr>
          <p:nvPr/>
        </p:nvSpPr>
        <p:spPr bwMode="auto">
          <a:xfrm>
            <a:off x="91592" y="2336760"/>
            <a:ext cx="38995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B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sp>
        <p:nvSpPr>
          <p:cNvPr id="91" name="テキスト ボックス 44"/>
          <p:cNvSpPr txBox="1">
            <a:spLocks noChangeArrowheads="1"/>
          </p:cNvSpPr>
          <p:nvPr/>
        </p:nvSpPr>
        <p:spPr bwMode="auto">
          <a:xfrm>
            <a:off x="3148976" y="2336760"/>
            <a:ext cx="406932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/>
                <a:cs typeface="Helvetica"/>
              </a:rPr>
              <a:t>C</a:t>
            </a:r>
            <a:endParaRPr lang="ja-JP" altLang="en-US" dirty="0">
              <a:latin typeface="Helvetica"/>
              <a:cs typeface="Helvetica"/>
            </a:endParaRPr>
          </a:p>
        </p:txBody>
      </p:sp>
      <p:sp>
        <p:nvSpPr>
          <p:cNvPr id="82" name="二等辺三角形 81"/>
          <p:cNvSpPr/>
          <p:nvPr/>
        </p:nvSpPr>
        <p:spPr>
          <a:xfrm>
            <a:off x="952870" y="3034145"/>
            <a:ext cx="60558" cy="45719"/>
          </a:xfrm>
          <a:prstGeom prst="triangl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cs typeface="Helvetica"/>
            </a:endParaRPr>
          </a:p>
        </p:txBody>
      </p:sp>
      <p:sp>
        <p:nvSpPr>
          <p:cNvPr id="83" name="円/楕円 82"/>
          <p:cNvSpPr/>
          <p:nvPr/>
        </p:nvSpPr>
        <p:spPr>
          <a:xfrm>
            <a:off x="945431" y="3258875"/>
            <a:ext cx="64355" cy="64349"/>
          </a:xfrm>
          <a:prstGeom prst="ellipse">
            <a:avLst/>
          </a:prstGeom>
          <a:solidFill>
            <a:srgbClr val="FF0000"/>
          </a:solidFill>
          <a:ln w="28575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b="1">
              <a:latin typeface="Helvetica"/>
              <a:cs typeface="Helvetica"/>
            </a:endParaRPr>
          </a:p>
        </p:txBody>
      </p:sp>
      <p:sp>
        <p:nvSpPr>
          <p:cNvPr id="84" name="正方形/長方形 83"/>
          <p:cNvSpPr/>
          <p:nvPr/>
        </p:nvSpPr>
        <p:spPr>
          <a:xfrm>
            <a:off x="626029" y="4609735"/>
            <a:ext cx="2502197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" name="正方形/長方形 3"/>
          <p:cNvSpPr/>
          <p:nvPr/>
        </p:nvSpPr>
        <p:spPr>
          <a:xfrm>
            <a:off x="539123" y="4677737"/>
            <a:ext cx="2589104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79394661-8AAD-894B-B321-DF2F09BB1A34}"/>
              </a:ext>
            </a:extLst>
          </p:cNvPr>
          <p:cNvSpPr txBox="1"/>
          <p:nvPr/>
        </p:nvSpPr>
        <p:spPr>
          <a:xfrm>
            <a:off x="718847" y="461717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64CEF990-A5BD-1841-BC92-8E9FF5558D96}"/>
              </a:ext>
            </a:extLst>
          </p:cNvPr>
          <p:cNvSpPr txBox="1"/>
          <p:nvPr/>
        </p:nvSpPr>
        <p:spPr>
          <a:xfrm>
            <a:off x="898572" y="461717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B6F9BB82-7EF2-C24B-863C-A6CC60B52B68}"/>
              </a:ext>
            </a:extLst>
          </p:cNvPr>
          <p:cNvSpPr txBox="1"/>
          <p:nvPr/>
        </p:nvSpPr>
        <p:spPr>
          <a:xfrm>
            <a:off x="1078297" y="461717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708A8313-4EBE-A84D-8CE5-144CF9CD6118}"/>
              </a:ext>
            </a:extLst>
          </p:cNvPr>
          <p:cNvSpPr txBox="1"/>
          <p:nvPr/>
        </p:nvSpPr>
        <p:spPr>
          <a:xfrm>
            <a:off x="1258022" y="461717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1437747" y="461717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EE14A61E-8929-9048-B5CD-28FB87B52101}"/>
              </a:ext>
            </a:extLst>
          </p:cNvPr>
          <p:cNvSpPr txBox="1"/>
          <p:nvPr/>
        </p:nvSpPr>
        <p:spPr>
          <a:xfrm>
            <a:off x="1703058" y="461717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AC43DEE9-DE8D-1F42-9452-B6EC573F5AEF}"/>
              </a:ext>
            </a:extLst>
          </p:cNvPr>
          <p:cNvSpPr txBox="1"/>
          <p:nvPr/>
        </p:nvSpPr>
        <p:spPr>
          <a:xfrm>
            <a:off x="1968369" y="461717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2233680" y="461717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DA6CE7E4-2C9E-4C44-9865-4688AC918023}"/>
              </a:ext>
            </a:extLst>
          </p:cNvPr>
          <p:cNvSpPr txBox="1"/>
          <p:nvPr/>
        </p:nvSpPr>
        <p:spPr>
          <a:xfrm>
            <a:off x="2498991" y="461717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C0F527A3-9827-C44F-AD18-EDB55DE1211A}"/>
              </a:ext>
            </a:extLst>
          </p:cNvPr>
          <p:cNvSpPr txBox="1"/>
          <p:nvPr/>
        </p:nvSpPr>
        <p:spPr>
          <a:xfrm>
            <a:off x="2764304" y="461717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006967" y="4806199"/>
            <a:ext cx="17748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charset="0"/>
                <a:ea typeface="Helvetica" charset="0"/>
                <a:cs typeface="Helvetica" charset="0"/>
              </a:rPr>
              <a:t>Days </a:t>
            </a:r>
            <a:r>
              <a:rPr lang="en-US" altLang="ja-JP" sz="1200" b="1">
                <a:latin typeface="Helvetica" charset="0"/>
                <a:ea typeface="Helvetica" charset="0"/>
                <a:cs typeface="Helvetica" charset="0"/>
              </a:rPr>
              <a:t>after monitoring</a:t>
            </a:r>
            <a:endParaRPr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79394661-8AAD-894B-B321-DF2F09BB1A34}"/>
              </a:ext>
            </a:extLst>
          </p:cNvPr>
          <p:cNvSpPr txBox="1"/>
          <p:nvPr/>
        </p:nvSpPr>
        <p:spPr>
          <a:xfrm>
            <a:off x="539122" y="4614633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6" name="二等辺三角形 85"/>
          <p:cNvSpPr/>
          <p:nvPr/>
        </p:nvSpPr>
        <p:spPr>
          <a:xfrm>
            <a:off x="4315570" y="4057015"/>
            <a:ext cx="60558" cy="45719"/>
          </a:xfrm>
          <a:prstGeom prst="triangl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cs typeface="Helvetica"/>
            </a:endParaRPr>
          </a:p>
        </p:txBody>
      </p:sp>
      <p:sp>
        <p:nvSpPr>
          <p:cNvPr id="89" name="円/楕円 88"/>
          <p:cNvSpPr/>
          <p:nvPr/>
        </p:nvSpPr>
        <p:spPr>
          <a:xfrm>
            <a:off x="4308131" y="4281745"/>
            <a:ext cx="64355" cy="64349"/>
          </a:xfrm>
          <a:prstGeom prst="ellipse">
            <a:avLst/>
          </a:prstGeom>
          <a:solidFill>
            <a:srgbClr val="FF0000"/>
          </a:solidFill>
          <a:ln w="28575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b="1">
              <a:latin typeface="Helvetica"/>
              <a:cs typeface="Helvetica"/>
            </a:endParaRPr>
          </a:p>
        </p:txBody>
      </p:sp>
      <p:sp>
        <p:nvSpPr>
          <p:cNvPr id="114" name="テキスト ボックス 44"/>
          <p:cNvSpPr txBox="1">
            <a:spLocks noChangeArrowheads="1"/>
          </p:cNvSpPr>
          <p:nvPr/>
        </p:nvSpPr>
        <p:spPr bwMode="auto">
          <a:xfrm>
            <a:off x="91592" y="489492"/>
            <a:ext cx="38995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A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sp>
        <p:nvSpPr>
          <p:cNvPr id="115" name="Line 239"/>
          <p:cNvSpPr>
            <a:spLocks noChangeShapeType="1"/>
          </p:cNvSpPr>
          <p:nvPr/>
        </p:nvSpPr>
        <p:spPr bwMode="auto">
          <a:xfrm flipV="1">
            <a:off x="946646" y="1223489"/>
            <a:ext cx="5085675" cy="14318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200" b="1" dirty="0"/>
          </a:p>
        </p:txBody>
      </p:sp>
      <p:sp>
        <p:nvSpPr>
          <p:cNvPr id="116" name="Line 239"/>
          <p:cNvSpPr>
            <a:spLocks noChangeShapeType="1"/>
          </p:cNvSpPr>
          <p:nvPr/>
        </p:nvSpPr>
        <p:spPr bwMode="auto">
          <a:xfrm flipV="1">
            <a:off x="958563" y="1257894"/>
            <a:ext cx="0" cy="19046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692955" y="144835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/>
                <a:cs typeface="Helvetica"/>
              </a:rPr>
              <a:t>ZIKA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8" name="Line 239"/>
          <p:cNvSpPr>
            <a:spLocks noChangeShapeType="1"/>
          </p:cNvSpPr>
          <p:nvPr/>
        </p:nvSpPr>
        <p:spPr bwMode="auto">
          <a:xfrm flipV="1">
            <a:off x="1893780" y="1260617"/>
            <a:ext cx="0" cy="19046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9" name="テキスト ボックス 118"/>
          <p:cNvSpPr txBox="1"/>
          <p:nvPr/>
        </p:nvSpPr>
        <p:spPr>
          <a:xfrm>
            <a:off x="1628172" y="144835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/>
                <a:cs typeface="Helvetica"/>
              </a:rPr>
              <a:t>ZIKA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0" name="Line 239"/>
          <p:cNvSpPr>
            <a:spLocks noChangeShapeType="1"/>
          </p:cNvSpPr>
          <p:nvPr/>
        </p:nvSpPr>
        <p:spPr bwMode="auto">
          <a:xfrm flipV="1">
            <a:off x="2786860" y="1257894"/>
            <a:ext cx="0" cy="19046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1" name="テキスト ボックス 120"/>
          <p:cNvSpPr txBox="1"/>
          <p:nvPr/>
        </p:nvSpPr>
        <p:spPr>
          <a:xfrm>
            <a:off x="2514312" y="144835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/>
                <a:cs typeface="Helvetica"/>
              </a:rPr>
              <a:t>ZIKA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2" name="テキスト ボックス 121"/>
          <p:cNvSpPr txBox="1"/>
          <p:nvPr/>
        </p:nvSpPr>
        <p:spPr>
          <a:xfrm>
            <a:off x="769206" y="876484"/>
            <a:ext cx="3642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/>
                <a:cs typeface="Helvetica"/>
              </a:rPr>
              <a:t>d0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3" name="テキスト ボックス 122"/>
          <p:cNvSpPr txBox="1"/>
          <p:nvPr/>
        </p:nvSpPr>
        <p:spPr>
          <a:xfrm>
            <a:off x="1698362" y="876484"/>
            <a:ext cx="3642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/>
                <a:cs typeface="Helvetica"/>
              </a:rPr>
              <a:t>d7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4" name="テキスト ボックス 123"/>
          <p:cNvSpPr txBox="1"/>
          <p:nvPr/>
        </p:nvSpPr>
        <p:spPr>
          <a:xfrm>
            <a:off x="2558820" y="876484"/>
            <a:ext cx="4498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/>
                <a:cs typeface="Helvetica"/>
              </a:rPr>
              <a:t>d14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5" name="Line 239"/>
          <p:cNvSpPr>
            <a:spLocks noChangeShapeType="1"/>
          </p:cNvSpPr>
          <p:nvPr/>
        </p:nvSpPr>
        <p:spPr bwMode="auto">
          <a:xfrm flipV="1">
            <a:off x="3452314" y="1246061"/>
            <a:ext cx="0" cy="19046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6" name="テキスト ボックス 125"/>
          <p:cNvSpPr txBox="1"/>
          <p:nvPr/>
        </p:nvSpPr>
        <p:spPr>
          <a:xfrm>
            <a:off x="3239073" y="876484"/>
            <a:ext cx="4498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/>
                <a:cs typeface="Helvetica"/>
              </a:rPr>
              <a:t>d19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3185858" y="1444509"/>
            <a:ext cx="24165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start the monitor of </a:t>
            </a:r>
          </a:p>
          <a:p>
            <a:r>
              <a:rPr lang="en-US" altLang="ja-JP" sz="1200" b="1" dirty="0">
                <a:latin typeface="Helvetica"/>
                <a:cs typeface="Helvetica"/>
              </a:rPr>
              <a:t>clinical score and body weight</a:t>
            </a:r>
          </a:p>
        </p:txBody>
      </p:sp>
      <p:grpSp>
        <p:nvGrpSpPr>
          <p:cNvPr id="128" name="Group 49"/>
          <p:cNvGrpSpPr>
            <a:grpSpLocks noChangeAspect="1"/>
          </p:cNvGrpSpPr>
          <p:nvPr/>
        </p:nvGrpSpPr>
        <p:grpSpPr bwMode="auto">
          <a:xfrm>
            <a:off x="129754" y="1090410"/>
            <a:ext cx="665289" cy="319999"/>
            <a:chOff x="1349" y="1287"/>
            <a:chExt cx="2716" cy="1276"/>
          </a:xfrm>
          <a:solidFill>
            <a:schemeClr val="tx1"/>
          </a:solidFill>
        </p:grpSpPr>
        <p:sp>
          <p:nvSpPr>
            <p:cNvPr id="129" name="Freeform 45"/>
            <p:cNvSpPr>
              <a:spLocks noChangeAspect="1"/>
            </p:cNvSpPr>
            <p:nvPr/>
          </p:nvSpPr>
          <p:spPr bwMode="auto">
            <a:xfrm>
              <a:off x="1349" y="1287"/>
              <a:ext cx="2716" cy="1276"/>
            </a:xfrm>
            <a:custGeom>
              <a:avLst/>
              <a:gdLst>
                <a:gd name="T0" fmla="*/ 1131 w 1150"/>
                <a:gd name="T1" fmla="*/ 359 h 540"/>
                <a:gd name="T2" fmla="*/ 1139 w 1150"/>
                <a:gd name="T3" fmla="*/ 309 h 540"/>
                <a:gd name="T4" fmla="*/ 1118 w 1150"/>
                <a:gd name="T5" fmla="*/ 255 h 540"/>
                <a:gd name="T6" fmla="*/ 1080 w 1150"/>
                <a:gd name="T7" fmla="*/ 220 h 540"/>
                <a:gd name="T8" fmla="*/ 1033 w 1150"/>
                <a:gd name="T9" fmla="*/ 128 h 540"/>
                <a:gd name="T10" fmla="*/ 964 w 1150"/>
                <a:gd name="T11" fmla="*/ 148 h 540"/>
                <a:gd name="T12" fmla="*/ 861 w 1150"/>
                <a:gd name="T13" fmla="*/ 125 h 540"/>
                <a:gd name="T14" fmla="*/ 498 w 1150"/>
                <a:gd name="T15" fmla="*/ 41 h 540"/>
                <a:gd name="T16" fmla="*/ 335 w 1150"/>
                <a:gd name="T17" fmla="*/ 217 h 540"/>
                <a:gd name="T18" fmla="*/ 86 w 1150"/>
                <a:gd name="T19" fmla="*/ 184 h 540"/>
                <a:gd name="T20" fmla="*/ 1 w 1150"/>
                <a:gd name="T21" fmla="*/ 274 h 540"/>
                <a:gd name="T22" fmla="*/ 107 w 1150"/>
                <a:gd name="T23" fmla="*/ 375 h 540"/>
                <a:gd name="T24" fmla="*/ 120 w 1150"/>
                <a:gd name="T25" fmla="*/ 369 h 540"/>
                <a:gd name="T26" fmla="*/ 26 w 1150"/>
                <a:gd name="T27" fmla="*/ 268 h 540"/>
                <a:gd name="T28" fmla="*/ 140 w 1150"/>
                <a:gd name="T29" fmla="*/ 202 h 540"/>
                <a:gd name="T30" fmla="*/ 338 w 1150"/>
                <a:gd name="T31" fmla="*/ 259 h 540"/>
                <a:gd name="T32" fmla="*/ 414 w 1150"/>
                <a:gd name="T33" fmla="*/ 303 h 540"/>
                <a:gd name="T34" fmla="*/ 452 w 1150"/>
                <a:gd name="T35" fmla="*/ 344 h 540"/>
                <a:gd name="T36" fmla="*/ 509 w 1150"/>
                <a:gd name="T37" fmla="*/ 379 h 540"/>
                <a:gd name="T38" fmla="*/ 540 w 1150"/>
                <a:gd name="T39" fmla="*/ 432 h 540"/>
                <a:gd name="T40" fmla="*/ 554 w 1150"/>
                <a:gd name="T41" fmla="*/ 445 h 540"/>
                <a:gd name="T42" fmla="*/ 558 w 1150"/>
                <a:gd name="T43" fmla="*/ 422 h 540"/>
                <a:gd name="T44" fmla="*/ 562 w 1150"/>
                <a:gd name="T45" fmla="*/ 410 h 540"/>
                <a:gd name="T46" fmla="*/ 593 w 1150"/>
                <a:gd name="T47" fmla="*/ 433 h 540"/>
                <a:gd name="T48" fmla="*/ 604 w 1150"/>
                <a:gd name="T49" fmla="*/ 424 h 540"/>
                <a:gd name="T50" fmla="*/ 612 w 1150"/>
                <a:gd name="T51" fmla="*/ 417 h 540"/>
                <a:gd name="T52" fmla="*/ 644 w 1150"/>
                <a:gd name="T53" fmla="*/ 432 h 540"/>
                <a:gd name="T54" fmla="*/ 609 w 1150"/>
                <a:gd name="T55" fmla="*/ 391 h 540"/>
                <a:gd name="T56" fmla="*/ 661 w 1150"/>
                <a:gd name="T57" fmla="*/ 415 h 540"/>
                <a:gd name="T58" fmla="*/ 596 w 1150"/>
                <a:gd name="T59" fmla="*/ 366 h 540"/>
                <a:gd name="T60" fmla="*/ 720 w 1150"/>
                <a:gd name="T61" fmla="*/ 388 h 540"/>
                <a:gd name="T62" fmla="*/ 799 w 1150"/>
                <a:gd name="T63" fmla="*/ 447 h 540"/>
                <a:gd name="T64" fmla="*/ 838 w 1150"/>
                <a:gd name="T65" fmla="*/ 509 h 540"/>
                <a:gd name="T66" fmla="*/ 848 w 1150"/>
                <a:gd name="T67" fmla="*/ 525 h 540"/>
                <a:gd name="T68" fmla="*/ 859 w 1150"/>
                <a:gd name="T69" fmla="*/ 494 h 540"/>
                <a:gd name="T70" fmla="*/ 879 w 1150"/>
                <a:gd name="T71" fmla="*/ 529 h 540"/>
                <a:gd name="T72" fmla="*/ 889 w 1150"/>
                <a:gd name="T73" fmla="*/ 523 h 540"/>
                <a:gd name="T74" fmla="*/ 878 w 1150"/>
                <a:gd name="T75" fmla="*/ 499 h 540"/>
                <a:gd name="T76" fmla="*/ 916 w 1150"/>
                <a:gd name="T77" fmla="*/ 525 h 540"/>
                <a:gd name="T78" fmla="*/ 925 w 1150"/>
                <a:gd name="T79" fmla="*/ 517 h 540"/>
                <a:gd name="T80" fmla="*/ 904 w 1150"/>
                <a:gd name="T81" fmla="*/ 493 h 540"/>
                <a:gd name="T82" fmla="*/ 946 w 1150"/>
                <a:gd name="T83" fmla="*/ 511 h 540"/>
                <a:gd name="T84" fmla="*/ 922 w 1150"/>
                <a:gd name="T85" fmla="*/ 482 h 540"/>
                <a:gd name="T86" fmla="*/ 897 w 1150"/>
                <a:gd name="T87" fmla="*/ 465 h 540"/>
                <a:gd name="T88" fmla="*/ 832 w 1150"/>
                <a:gd name="T89" fmla="*/ 425 h 540"/>
                <a:gd name="T90" fmla="*/ 900 w 1150"/>
                <a:gd name="T91" fmla="*/ 395 h 540"/>
                <a:gd name="T92" fmla="*/ 926 w 1150"/>
                <a:gd name="T93" fmla="*/ 440 h 540"/>
                <a:gd name="T94" fmla="*/ 970 w 1150"/>
                <a:gd name="T95" fmla="*/ 458 h 540"/>
                <a:gd name="T96" fmla="*/ 982 w 1150"/>
                <a:gd name="T97" fmla="*/ 458 h 540"/>
                <a:gd name="T98" fmla="*/ 1013 w 1150"/>
                <a:gd name="T99" fmla="*/ 461 h 540"/>
                <a:gd name="T100" fmla="*/ 1036 w 1150"/>
                <a:gd name="T101" fmla="*/ 469 h 540"/>
                <a:gd name="T102" fmla="*/ 1013 w 1150"/>
                <a:gd name="T103" fmla="*/ 445 h 540"/>
                <a:gd name="T104" fmla="*/ 1056 w 1150"/>
                <a:gd name="T105" fmla="*/ 454 h 540"/>
                <a:gd name="T106" fmla="*/ 1045 w 1150"/>
                <a:gd name="T107" fmla="*/ 440 h 540"/>
                <a:gd name="T108" fmla="*/ 1041 w 1150"/>
                <a:gd name="T109" fmla="*/ 435 h 540"/>
                <a:gd name="T110" fmla="*/ 1017 w 1150"/>
                <a:gd name="T111" fmla="*/ 424 h 540"/>
                <a:gd name="T112" fmla="*/ 971 w 1150"/>
                <a:gd name="T113" fmla="*/ 412 h 540"/>
                <a:gd name="T114" fmla="*/ 954 w 1150"/>
                <a:gd name="T115" fmla="*/ 386 h 540"/>
                <a:gd name="T116" fmla="*/ 1023 w 1150"/>
                <a:gd name="T117" fmla="*/ 358 h 5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1150" h="540">
                  <a:moveTo>
                    <a:pt x="1088" y="361"/>
                  </a:moveTo>
                  <a:cubicBezTo>
                    <a:pt x="1093" y="362"/>
                    <a:pt x="1121" y="362"/>
                    <a:pt x="1131" y="359"/>
                  </a:cubicBezTo>
                  <a:cubicBezTo>
                    <a:pt x="1142" y="356"/>
                    <a:pt x="1144" y="359"/>
                    <a:pt x="1147" y="349"/>
                  </a:cubicBezTo>
                  <a:cubicBezTo>
                    <a:pt x="1150" y="339"/>
                    <a:pt x="1143" y="320"/>
                    <a:pt x="1139" y="309"/>
                  </a:cubicBezTo>
                  <a:cubicBezTo>
                    <a:pt x="1136" y="297"/>
                    <a:pt x="1126" y="283"/>
                    <a:pt x="1123" y="274"/>
                  </a:cubicBezTo>
                  <a:cubicBezTo>
                    <a:pt x="1120" y="265"/>
                    <a:pt x="1121" y="260"/>
                    <a:pt x="1118" y="255"/>
                  </a:cubicBezTo>
                  <a:cubicBezTo>
                    <a:pt x="1115" y="250"/>
                    <a:pt x="1111" y="249"/>
                    <a:pt x="1103" y="243"/>
                  </a:cubicBezTo>
                  <a:cubicBezTo>
                    <a:pt x="1097" y="238"/>
                    <a:pt x="1090" y="233"/>
                    <a:pt x="1080" y="220"/>
                  </a:cubicBezTo>
                  <a:cubicBezTo>
                    <a:pt x="1069" y="207"/>
                    <a:pt x="1043" y="181"/>
                    <a:pt x="1036" y="165"/>
                  </a:cubicBezTo>
                  <a:cubicBezTo>
                    <a:pt x="1029" y="150"/>
                    <a:pt x="1035" y="140"/>
                    <a:pt x="1033" y="128"/>
                  </a:cubicBezTo>
                  <a:cubicBezTo>
                    <a:pt x="1033" y="115"/>
                    <a:pt x="1021" y="42"/>
                    <a:pt x="986" y="117"/>
                  </a:cubicBezTo>
                  <a:cubicBezTo>
                    <a:pt x="980" y="129"/>
                    <a:pt x="974" y="143"/>
                    <a:pt x="964" y="148"/>
                  </a:cubicBezTo>
                  <a:cubicBezTo>
                    <a:pt x="954" y="152"/>
                    <a:pt x="942" y="145"/>
                    <a:pt x="923" y="140"/>
                  </a:cubicBezTo>
                  <a:cubicBezTo>
                    <a:pt x="907" y="137"/>
                    <a:pt x="882" y="136"/>
                    <a:pt x="861" y="125"/>
                  </a:cubicBezTo>
                  <a:cubicBezTo>
                    <a:pt x="839" y="115"/>
                    <a:pt x="827" y="94"/>
                    <a:pt x="797" y="77"/>
                  </a:cubicBezTo>
                  <a:cubicBezTo>
                    <a:pt x="741" y="46"/>
                    <a:pt x="620" y="0"/>
                    <a:pt x="498" y="41"/>
                  </a:cubicBezTo>
                  <a:cubicBezTo>
                    <a:pt x="456" y="56"/>
                    <a:pt x="381" y="110"/>
                    <a:pt x="360" y="164"/>
                  </a:cubicBezTo>
                  <a:cubicBezTo>
                    <a:pt x="352" y="185"/>
                    <a:pt x="365" y="214"/>
                    <a:pt x="335" y="217"/>
                  </a:cubicBezTo>
                  <a:cubicBezTo>
                    <a:pt x="305" y="220"/>
                    <a:pt x="223" y="188"/>
                    <a:pt x="180" y="183"/>
                  </a:cubicBezTo>
                  <a:cubicBezTo>
                    <a:pt x="139" y="178"/>
                    <a:pt x="112" y="178"/>
                    <a:pt x="86" y="184"/>
                  </a:cubicBezTo>
                  <a:cubicBezTo>
                    <a:pt x="60" y="191"/>
                    <a:pt x="40" y="204"/>
                    <a:pt x="25" y="219"/>
                  </a:cubicBezTo>
                  <a:cubicBezTo>
                    <a:pt x="12" y="233"/>
                    <a:pt x="0" y="257"/>
                    <a:pt x="1" y="274"/>
                  </a:cubicBezTo>
                  <a:cubicBezTo>
                    <a:pt x="1" y="290"/>
                    <a:pt x="13" y="305"/>
                    <a:pt x="31" y="321"/>
                  </a:cubicBezTo>
                  <a:cubicBezTo>
                    <a:pt x="48" y="338"/>
                    <a:pt x="88" y="356"/>
                    <a:pt x="107" y="375"/>
                  </a:cubicBezTo>
                  <a:cubicBezTo>
                    <a:pt x="125" y="395"/>
                    <a:pt x="142" y="441"/>
                    <a:pt x="144" y="439"/>
                  </a:cubicBezTo>
                  <a:cubicBezTo>
                    <a:pt x="147" y="438"/>
                    <a:pt x="136" y="390"/>
                    <a:pt x="120" y="369"/>
                  </a:cubicBezTo>
                  <a:cubicBezTo>
                    <a:pt x="106" y="348"/>
                    <a:pt x="72" y="330"/>
                    <a:pt x="54" y="314"/>
                  </a:cubicBezTo>
                  <a:cubicBezTo>
                    <a:pt x="36" y="299"/>
                    <a:pt x="25" y="282"/>
                    <a:pt x="26" y="268"/>
                  </a:cubicBezTo>
                  <a:cubicBezTo>
                    <a:pt x="27" y="252"/>
                    <a:pt x="42" y="232"/>
                    <a:pt x="60" y="222"/>
                  </a:cubicBezTo>
                  <a:cubicBezTo>
                    <a:pt x="77" y="211"/>
                    <a:pt x="104" y="199"/>
                    <a:pt x="140" y="202"/>
                  </a:cubicBezTo>
                  <a:cubicBezTo>
                    <a:pt x="176" y="204"/>
                    <a:pt x="241" y="229"/>
                    <a:pt x="274" y="238"/>
                  </a:cubicBezTo>
                  <a:cubicBezTo>
                    <a:pt x="306" y="247"/>
                    <a:pt x="321" y="252"/>
                    <a:pt x="338" y="259"/>
                  </a:cubicBezTo>
                  <a:cubicBezTo>
                    <a:pt x="357" y="263"/>
                    <a:pt x="370" y="263"/>
                    <a:pt x="382" y="271"/>
                  </a:cubicBezTo>
                  <a:cubicBezTo>
                    <a:pt x="394" y="278"/>
                    <a:pt x="406" y="295"/>
                    <a:pt x="414" y="303"/>
                  </a:cubicBezTo>
                  <a:cubicBezTo>
                    <a:pt x="421" y="314"/>
                    <a:pt x="419" y="322"/>
                    <a:pt x="426" y="330"/>
                  </a:cubicBezTo>
                  <a:cubicBezTo>
                    <a:pt x="433" y="336"/>
                    <a:pt x="442" y="338"/>
                    <a:pt x="452" y="344"/>
                  </a:cubicBezTo>
                  <a:cubicBezTo>
                    <a:pt x="460" y="348"/>
                    <a:pt x="467" y="354"/>
                    <a:pt x="477" y="360"/>
                  </a:cubicBezTo>
                  <a:cubicBezTo>
                    <a:pt x="485" y="366"/>
                    <a:pt x="501" y="372"/>
                    <a:pt x="509" y="379"/>
                  </a:cubicBezTo>
                  <a:cubicBezTo>
                    <a:pt x="517" y="387"/>
                    <a:pt x="522" y="398"/>
                    <a:pt x="528" y="406"/>
                  </a:cubicBezTo>
                  <a:cubicBezTo>
                    <a:pt x="533" y="415"/>
                    <a:pt x="537" y="425"/>
                    <a:pt x="540" y="432"/>
                  </a:cubicBezTo>
                  <a:cubicBezTo>
                    <a:pt x="544" y="437"/>
                    <a:pt x="547" y="437"/>
                    <a:pt x="549" y="439"/>
                  </a:cubicBezTo>
                  <a:cubicBezTo>
                    <a:pt x="551" y="441"/>
                    <a:pt x="553" y="445"/>
                    <a:pt x="554" y="445"/>
                  </a:cubicBezTo>
                  <a:cubicBezTo>
                    <a:pt x="556" y="445"/>
                    <a:pt x="556" y="441"/>
                    <a:pt x="556" y="437"/>
                  </a:cubicBezTo>
                  <a:cubicBezTo>
                    <a:pt x="557" y="434"/>
                    <a:pt x="559" y="427"/>
                    <a:pt x="558" y="422"/>
                  </a:cubicBezTo>
                  <a:cubicBezTo>
                    <a:pt x="556" y="415"/>
                    <a:pt x="548" y="406"/>
                    <a:pt x="549" y="404"/>
                  </a:cubicBezTo>
                  <a:cubicBezTo>
                    <a:pt x="549" y="402"/>
                    <a:pt x="557" y="406"/>
                    <a:pt x="562" y="410"/>
                  </a:cubicBezTo>
                  <a:cubicBezTo>
                    <a:pt x="565" y="413"/>
                    <a:pt x="572" y="420"/>
                    <a:pt x="577" y="424"/>
                  </a:cubicBezTo>
                  <a:cubicBezTo>
                    <a:pt x="584" y="429"/>
                    <a:pt x="588" y="429"/>
                    <a:pt x="593" y="433"/>
                  </a:cubicBezTo>
                  <a:cubicBezTo>
                    <a:pt x="597" y="437"/>
                    <a:pt x="602" y="448"/>
                    <a:pt x="604" y="447"/>
                  </a:cubicBezTo>
                  <a:cubicBezTo>
                    <a:pt x="607" y="446"/>
                    <a:pt x="608" y="432"/>
                    <a:pt x="604" y="424"/>
                  </a:cubicBezTo>
                  <a:cubicBezTo>
                    <a:pt x="600" y="417"/>
                    <a:pt x="581" y="401"/>
                    <a:pt x="582" y="400"/>
                  </a:cubicBezTo>
                  <a:cubicBezTo>
                    <a:pt x="584" y="398"/>
                    <a:pt x="604" y="412"/>
                    <a:pt x="612" y="417"/>
                  </a:cubicBezTo>
                  <a:cubicBezTo>
                    <a:pt x="620" y="420"/>
                    <a:pt x="627" y="421"/>
                    <a:pt x="633" y="423"/>
                  </a:cubicBezTo>
                  <a:cubicBezTo>
                    <a:pt x="637" y="425"/>
                    <a:pt x="644" y="434"/>
                    <a:pt x="644" y="432"/>
                  </a:cubicBezTo>
                  <a:cubicBezTo>
                    <a:pt x="646" y="429"/>
                    <a:pt x="645" y="417"/>
                    <a:pt x="640" y="410"/>
                  </a:cubicBezTo>
                  <a:cubicBezTo>
                    <a:pt x="634" y="404"/>
                    <a:pt x="608" y="392"/>
                    <a:pt x="609" y="391"/>
                  </a:cubicBezTo>
                  <a:cubicBezTo>
                    <a:pt x="610" y="390"/>
                    <a:pt x="635" y="402"/>
                    <a:pt x="644" y="406"/>
                  </a:cubicBezTo>
                  <a:cubicBezTo>
                    <a:pt x="654" y="410"/>
                    <a:pt x="660" y="417"/>
                    <a:pt x="661" y="415"/>
                  </a:cubicBezTo>
                  <a:cubicBezTo>
                    <a:pt x="662" y="413"/>
                    <a:pt x="658" y="403"/>
                    <a:pt x="647" y="395"/>
                  </a:cubicBezTo>
                  <a:cubicBezTo>
                    <a:pt x="636" y="387"/>
                    <a:pt x="593" y="368"/>
                    <a:pt x="596" y="366"/>
                  </a:cubicBezTo>
                  <a:cubicBezTo>
                    <a:pt x="599" y="362"/>
                    <a:pt x="644" y="374"/>
                    <a:pt x="664" y="378"/>
                  </a:cubicBezTo>
                  <a:cubicBezTo>
                    <a:pt x="684" y="381"/>
                    <a:pt x="708" y="382"/>
                    <a:pt x="720" y="388"/>
                  </a:cubicBezTo>
                  <a:cubicBezTo>
                    <a:pt x="732" y="394"/>
                    <a:pt x="723" y="401"/>
                    <a:pt x="735" y="410"/>
                  </a:cubicBezTo>
                  <a:cubicBezTo>
                    <a:pt x="749" y="420"/>
                    <a:pt x="782" y="436"/>
                    <a:pt x="799" y="447"/>
                  </a:cubicBezTo>
                  <a:cubicBezTo>
                    <a:pt x="814" y="458"/>
                    <a:pt x="822" y="467"/>
                    <a:pt x="826" y="477"/>
                  </a:cubicBezTo>
                  <a:cubicBezTo>
                    <a:pt x="835" y="487"/>
                    <a:pt x="835" y="502"/>
                    <a:pt x="838" y="509"/>
                  </a:cubicBezTo>
                  <a:cubicBezTo>
                    <a:pt x="841" y="516"/>
                    <a:pt x="844" y="515"/>
                    <a:pt x="846" y="517"/>
                  </a:cubicBezTo>
                  <a:cubicBezTo>
                    <a:pt x="848" y="521"/>
                    <a:pt x="846" y="527"/>
                    <a:pt x="848" y="525"/>
                  </a:cubicBezTo>
                  <a:cubicBezTo>
                    <a:pt x="850" y="524"/>
                    <a:pt x="854" y="514"/>
                    <a:pt x="857" y="509"/>
                  </a:cubicBezTo>
                  <a:cubicBezTo>
                    <a:pt x="859" y="505"/>
                    <a:pt x="856" y="493"/>
                    <a:pt x="859" y="494"/>
                  </a:cubicBezTo>
                  <a:cubicBezTo>
                    <a:pt x="861" y="496"/>
                    <a:pt x="867" y="514"/>
                    <a:pt x="871" y="521"/>
                  </a:cubicBezTo>
                  <a:cubicBezTo>
                    <a:pt x="874" y="526"/>
                    <a:pt x="876" y="527"/>
                    <a:pt x="879" y="529"/>
                  </a:cubicBezTo>
                  <a:cubicBezTo>
                    <a:pt x="882" y="533"/>
                    <a:pt x="885" y="540"/>
                    <a:pt x="886" y="539"/>
                  </a:cubicBezTo>
                  <a:cubicBezTo>
                    <a:pt x="887" y="537"/>
                    <a:pt x="889" y="527"/>
                    <a:pt x="889" y="523"/>
                  </a:cubicBezTo>
                  <a:cubicBezTo>
                    <a:pt x="889" y="518"/>
                    <a:pt x="887" y="517"/>
                    <a:pt x="886" y="512"/>
                  </a:cubicBezTo>
                  <a:cubicBezTo>
                    <a:pt x="884" y="508"/>
                    <a:pt x="875" y="498"/>
                    <a:pt x="878" y="499"/>
                  </a:cubicBezTo>
                  <a:cubicBezTo>
                    <a:pt x="882" y="499"/>
                    <a:pt x="900" y="512"/>
                    <a:pt x="906" y="517"/>
                  </a:cubicBezTo>
                  <a:cubicBezTo>
                    <a:pt x="911" y="521"/>
                    <a:pt x="912" y="523"/>
                    <a:pt x="916" y="525"/>
                  </a:cubicBezTo>
                  <a:cubicBezTo>
                    <a:pt x="919" y="527"/>
                    <a:pt x="925" y="531"/>
                    <a:pt x="926" y="530"/>
                  </a:cubicBezTo>
                  <a:cubicBezTo>
                    <a:pt x="928" y="529"/>
                    <a:pt x="926" y="521"/>
                    <a:pt x="925" y="517"/>
                  </a:cubicBezTo>
                  <a:cubicBezTo>
                    <a:pt x="923" y="513"/>
                    <a:pt x="920" y="511"/>
                    <a:pt x="917" y="506"/>
                  </a:cubicBezTo>
                  <a:cubicBezTo>
                    <a:pt x="913" y="502"/>
                    <a:pt x="902" y="493"/>
                    <a:pt x="904" y="493"/>
                  </a:cubicBezTo>
                  <a:cubicBezTo>
                    <a:pt x="907" y="493"/>
                    <a:pt x="924" y="502"/>
                    <a:pt x="932" y="505"/>
                  </a:cubicBezTo>
                  <a:cubicBezTo>
                    <a:pt x="938" y="509"/>
                    <a:pt x="945" y="513"/>
                    <a:pt x="946" y="511"/>
                  </a:cubicBezTo>
                  <a:cubicBezTo>
                    <a:pt x="947" y="509"/>
                    <a:pt x="944" y="501"/>
                    <a:pt x="940" y="496"/>
                  </a:cubicBezTo>
                  <a:cubicBezTo>
                    <a:pt x="935" y="490"/>
                    <a:pt x="924" y="486"/>
                    <a:pt x="922" y="482"/>
                  </a:cubicBezTo>
                  <a:cubicBezTo>
                    <a:pt x="918" y="478"/>
                    <a:pt x="924" y="475"/>
                    <a:pt x="921" y="473"/>
                  </a:cubicBezTo>
                  <a:cubicBezTo>
                    <a:pt x="917" y="469"/>
                    <a:pt x="904" y="466"/>
                    <a:pt x="897" y="465"/>
                  </a:cubicBezTo>
                  <a:cubicBezTo>
                    <a:pt x="889" y="461"/>
                    <a:pt x="886" y="466"/>
                    <a:pt x="874" y="458"/>
                  </a:cubicBezTo>
                  <a:cubicBezTo>
                    <a:pt x="863" y="452"/>
                    <a:pt x="836" y="435"/>
                    <a:pt x="832" y="425"/>
                  </a:cubicBezTo>
                  <a:cubicBezTo>
                    <a:pt x="828" y="415"/>
                    <a:pt x="839" y="403"/>
                    <a:pt x="851" y="398"/>
                  </a:cubicBezTo>
                  <a:cubicBezTo>
                    <a:pt x="862" y="394"/>
                    <a:pt x="889" y="394"/>
                    <a:pt x="900" y="395"/>
                  </a:cubicBezTo>
                  <a:cubicBezTo>
                    <a:pt x="910" y="397"/>
                    <a:pt x="908" y="401"/>
                    <a:pt x="913" y="408"/>
                  </a:cubicBezTo>
                  <a:cubicBezTo>
                    <a:pt x="918" y="416"/>
                    <a:pt x="921" y="433"/>
                    <a:pt x="926" y="440"/>
                  </a:cubicBezTo>
                  <a:cubicBezTo>
                    <a:pt x="932" y="447"/>
                    <a:pt x="943" y="447"/>
                    <a:pt x="950" y="450"/>
                  </a:cubicBezTo>
                  <a:cubicBezTo>
                    <a:pt x="957" y="454"/>
                    <a:pt x="966" y="455"/>
                    <a:pt x="970" y="458"/>
                  </a:cubicBezTo>
                  <a:cubicBezTo>
                    <a:pt x="974" y="460"/>
                    <a:pt x="977" y="465"/>
                    <a:pt x="979" y="465"/>
                  </a:cubicBezTo>
                  <a:cubicBezTo>
                    <a:pt x="980" y="465"/>
                    <a:pt x="982" y="461"/>
                    <a:pt x="982" y="458"/>
                  </a:cubicBezTo>
                  <a:cubicBezTo>
                    <a:pt x="982" y="455"/>
                    <a:pt x="973" y="445"/>
                    <a:pt x="979" y="445"/>
                  </a:cubicBezTo>
                  <a:cubicBezTo>
                    <a:pt x="983" y="446"/>
                    <a:pt x="1005" y="458"/>
                    <a:pt x="1013" y="461"/>
                  </a:cubicBezTo>
                  <a:cubicBezTo>
                    <a:pt x="1020" y="464"/>
                    <a:pt x="1022" y="463"/>
                    <a:pt x="1027" y="464"/>
                  </a:cubicBezTo>
                  <a:cubicBezTo>
                    <a:pt x="1030" y="465"/>
                    <a:pt x="1035" y="469"/>
                    <a:pt x="1036" y="469"/>
                  </a:cubicBezTo>
                  <a:cubicBezTo>
                    <a:pt x="1037" y="468"/>
                    <a:pt x="1036" y="461"/>
                    <a:pt x="1032" y="457"/>
                  </a:cubicBezTo>
                  <a:cubicBezTo>
                    <a:pt x="1029" y="454"/>
                    <a:pt x="1010" y="446"/>
                    <a:pt x="1013" y="445"/>
                  </a:cubicBezTo>
                  <a:cubicBezTo>
                    <a:pt x="1016" y="443"/>
                    <a:pt x="1039" y="449"/>
                    <a:pt x="1045" y="450"/>
                  </a:cubicBezTo>
                  <a:cubicBezTo>
                    <a:pt x="1053" y="451"/>
                    <a:pt x="1055" y="454"/>
                    <a:pt x="1056" y="454"/>
                  </a:cubicBezTo>
                  <a:cubicBezTo>
                    <a:pt x="1057" y="452"/>
                    <a:pt x="1052" y="449"/>
                    <a:pt x="1050" y="447"/>
                  </a:cubicBezTo>
                  <a:cubicBezTo>
                    <a:pt x="1049" y="445"/>
                    <a:pt x="1052" y="442"/>
                    <a:pt x="1045" y="440"/>
                  </a:cubicBezTo>
                  <a:cubicBezTo>
                    <a:pt x="1039" y="437"/>
                    <a:pt x="1013" y="432"/>
                    <a:pt x="1013" y="432"/>
                  </a:cubicBezTo>
                  <a:cubicBezTo>
                    <a:pt x="1012" y="430"/>
                    <a:pt x="1039" y="435"/>
                    <a:pt x="1041" y="435"/>
                  </a:cubicBezTo>
                  <a:cubicBezTo>
                    <a:pt x="1044" y="434"/>
                    <a:pt x="1033" y="430"/>
                    <a:pt x="1029" y="429"/>
                  </a:cubicBezTo>
                  <a:cubicBezTo>
                    <a:pt x="1025" y="426"/>
                    <a:pt x="1018" y="425"/>
                    <a:pt x="1017" y="424"/>
                  </a:cubicBezTo>
                  <a:cubicBezTo>
                    <a:pt x="1014" y="423"/>
                    <a:pt x="1021" y="418"/>
                    <a:pt x="1015" y="417"/>
                  </a:cubicBezTo>
                  <a:cubicBezTo>
                    <a:pt x="1008" y="414"/>
                    <a:pt x="982" y="415"/>
                    <a:pt x="971" y="412"/>
                  </a:cubicBezTo>
                  <a:cubicBezTo>
                    <a:pt x="962" y="410"/>
                    <a:pt x="958" y="401"/>
                    <a:pt x="955" y="397"/>
                  </a:cubicBezTo>
                  <a:cubicBezTo>
                    <a:pt x="953" y="392"/>
                    <a:pt x="948" y="389"/>
                    <a:pt x="954" y="386"/>
                  </a:cubicBezTo>
                  <a:cubicBezTo>
                    <a:pt x="959" y="382"/>
                    <a:pt x="976" y="379"/>
                    <a:pt x="986" y="375"/>
                  </a:cubicBezTo>
                  <a:cubicBezTo>
                    <a:pt x="996" y="372"/>
                    <a:pt x="1003" y="363"/>
                    <a:pt x="1023" y="358"/>
                  </a:cubicBezTo>
                  <a:cubicBezTo>
                    <a:pt x="1043" y="353"/>
                    <a:pt x="1088" y="361"/>
                    <a:pt x="1088" y="361"/>
                  </a:cubicBezTo>
                  <a:close/>
                </a:path>
              </a:pathLst>
            </a:custGeom>
            <a:grpFill/>
            <a:ln w="6350" cap="rnd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/>
            <a:lstStyle/>
            <a:p>
              <a:endParaRPr lang="ja-JP" altLang="en-US" sz="1400">
                <a:ln>
                  <a:solidFill>
                    <a:srgbClr val="000000"/>
                  </a:solidFill>
                </a:ln>
              </a:endParaRPr>
            </a:p>
          </p:txBody>
        </p:sp>
        <p:sp>
          <p:nvSpPr>
            <p:cNvPr id="130" name="Freeform 46"/>
            <p:cNvSpPr>
              <a:spLocks noChangeAspect="1"/>
            </p:cNvSpPr>
            <p:nvPr/>
          </p:nvSpPr>
          <p:spPr bwMode="auto">
            <a:xfrm>
              <a:off x="3248" y="1637"/>
              <a:ext cx="274" cy="236"/>
            </a:xfrm>
            <a:custGeom>
              <a:avLst/>
              <a:gdLst>
                <a:gd name="T0" fmla="*/ 72 w 116"/>
                <a:gd name="T1" fmla="*/ 100 h 100"/>
                <a:gd name="T2" fmla="*/ 51 w 116"/>
                <a:gd name="T3" fmla="*/ 1 h 100"/>
                <a:gd name="T4" fmla="*/ 116 w 116"/>
                <a:gd name="T5" fmla="*/ 87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6" h="100">
                  <a:moveTo>
                    <a:pt x="72" y="100"/>
                  </a:moveTo>
                  <a:cubicBezTo>
                    <a:pt x="0" y="36"/>
                    <a:pt x="40" y="2"/>
                    <a:pt x="51" y="1"/>
                  </a:cubicBezTo>
                  <a:cubicBezTo>
                    <a:pt x="62" y="0"/>
                    <a:pt x="113" y="13"/>
                    <a:pt x="116" y="87"/>
                  </a:cubicBezTo>
                </a:path>
              </a:pathLst>
            </a:custGeom>
            <a:grpFill/>
            <a:ln w="6350" cap="rnd">
              <a:solidFill>
                <a:schemeClr val="bg1"/>
              </a:solidFill>
              <a:prstDash val="solid"/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ja-JP" altLang="en-US" sz="1400">
                <a:ln>
                  <a:solidFill>
                    <a:srgbClr val="000000"/>
                  </a:solidFill>
                </a:ln>
              </a:endParaRPr>
            </a:p>
          </p:txBody>
        </p:sp>
        <p:sp>
          <p:nvSpPr>
            <p:cNvPr id="131" name="Freeform 47"/>
            <p:cNvSpPr>
              <a:spLocks noChangeAspect="1"/>
            </p:cNvSpPr>
            <p:nvPr/>
          </p:nvSpPr>
          <p:spPr bwMode="auto">
            <a:xfrm>
              <a:off x="3649" y="1542"/>
              <a:ext cx="76" cy="135"/>
            </a:xfrm>
            <a:custGeom>
              <a:avLst/>
              <a:gdLst>
                <a:gd name="T0" fmla="*/ 16 w 32"/>
                <a:gd name="T1" fmla="*/ 0 h 57"/>
                <a:gd name="T2" fmla="*/ 32 w 32"/>
                <a:gd name="T3" fmla="*/ 57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</a:cxnLst>
              <a:rect l="0" t="0" r="r" b="b"/>
              <a:pathLst>
                <a:path w="32" h="57">
                  <a:moveTo>
                    <a:pt x="16" y="0"/>
                  </a:moveTo>
                  <a:cubicBezTo>
                    <a:pt x="5" y="24"/>
                    <a:pt x="0" y="30"/>
                    <a:pt x="32" y="57"/>
                  </a:cubicBezTo>
                </a:path>
              </a:pathLst>
            </a:custGeom>
            <a:grpFill/>
            <a:ln w="6350" cap="rnd">
              <a:solidFill>
                <a:schemeClr val="bg1"/>
              </a:solidFill>
              <a:prstDash val="solid"/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ja-JP" altLang="en-US" sz="1400">
                <a:ln>
                  <a:solidFill>
                    <a:srgbClr val="000000"/>
                  </a:solidFill>
                </a:ln>
              </a:endParaRPr>
            </a:p>
          </p:txBody>
        </p:sp>
        <p:sp>
          <p:nvSpPr>
            <p:cNvPr id="132" name="Oval 48"/>
            <p:cNvSpPr>
              <a:spLocks noChangeAspect="1" noChangeArrowheads="1"/>
            </p:cNvSpPr>
            <p:nvPr/>
          </p:nvSpPr>
          <p:spPr bwMode="auto">
            <a:xfrm>
              <a:off x="3786" y="1924"/>
              <a:ext cx="75" cy="51"/>
            </a:xfrm>
            <a:prstGeom prst="ellipse">
              <a:avLst/>
            </a:prstGeom>
            <a:grpFill/>
            <a:ln w="6350" cap="rnd">
              <a:solidFill>
                <a:schemeClr val="bg1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ja-JP" altLang="en-US" sz="1400">
                <a:ln>
                  <a:solidFill>
                    <a:srgbClr val="000000"/>
                  </a:solidFill>
                </a:ln>
              </a:endParaRPr>
            </a:p>
          </p:txBody>
        </p:sp>
      </p:grpSp>
      <p:sp>
        <p:nvSpPr>
          <p:cNvPr id="135" name="テキスト ボックス 134"/>
          <p:cNvSpPr txBox="1"/>
          <p:nvPr/>
        </p:nvSpPr>
        <p:spPr>
          <a:xfrm>
            <a:off x="5819080" y="876484"/>
            <a:ext cx="4498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/>
                <a:cs typeface="Helvetica"/>
              </a:rPr>
              <a:t>d40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4354703" y="4806199"/>
            <a:ext cx="17748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charset="0"/>
                <a:ea typeface="Helvetica" charset="0"/>
                <a:cs typeface="Helvetica" charset="0"/>
              </a:rPr>
              <a:t>Days </a:t>
            </a:r>
            <a:r>
              <a:rPr lang="en-US" altLang="ja-JP" sz="1200" b="1">
                <a:latin typeface="Helvetica" charset="0"/>
                <a:ea typeface="Helvetica" charset="0"/>
                <a:cs typeface="Helvetica" charset="0"/>
              </a:rPr>
              <a:t>after monitoring</a:t>
            </a:r>
            <a:endParaRPr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494890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28575">
          <a:solidFill>
            <a:schemeClr val="tx1"/>
          </a:solidFill>
        </a:ln>
        <a:effectLst/>
      </a:spPr>
      <a:bodyPr rtlCol="0" anchor="ctr"/>
      <a:lstStyle>
        <a:defPPr algn="ctr">
          <a:defRPr sz="1200" b="1">
            <a:latin typeface="Helvetica"/>
            <a:cs typeface="Helvetica"/>
          </a:defRPr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77</TotalTime>
  <Words>74</Words>
  <Application>Microsoft Macintosh PowerPoint</Application>
  <PresentationFormat>画面に合わせる (4:3)</PresentationFormat>
  <Paragraphs>5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Calibri</vt:lpstr>
      <vt:lpstr>Helvetica</vt:lpstr>
      <vt:lpstr>ＭＳ Ｐゴシック</vt:lpstr>
      <vt:lpstr>Arial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IDC</dc:creator>
  <cp:keywords/>
  <dc:description/>
  <cp:lastModifiedBy>神山長慶</cp:lastModifiedBy>
  <cp:revision>329</cp:revision>
  <cp:lastPrinted>2024-05-22T05:30:17Z</cp:lastPrinted>
  <dcterms:created xsi:type="dcterms:W3CDTF">2022-03-10T04:52:23Z</dcterms:created>
  <dcterms:modified xsi:type="dcterms:W3CDTF">2025-05-01T06:21:56Z</dcterms:modified>
  <cp:category/>
</cp:coreProperties>
</file>